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796088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E4870C-012E-4774-B11A-83E50DC4EB0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0B333B-3981-4345-85E2-9CB81052CC1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5AFFC1D-7FC0-4232-87DA-859B8C97F68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A8BB27-DA8D-4DA9-89D0-9172D5E322C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A5BE4E-B34B-450D-8C2F-69761A45AB6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9E96BA-BA13-4573-83A5-DEC290F1872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717889F-781B-40ED-8987-6F54287A0D3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D7DF3B-746E-4C46-B768-00D02E633C6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2DB494-B805-4D4F-A30C-DAC168F1BA5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B97B9F-9A79-4A93-90B8-9870333FA0F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F57AAE-B951-4394-9E5F-882BA942843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098E4D-F445-414C-9E9D-0C647698D96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6DFCD53-35FF-43C9-8009-97EC94914C6E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tretch/>
        </p:blipFill>
        <p:spPr>
          <a:xfrm>
            <a:off x="1096920" y="2103480"/>
            <a:ext cx="4848120" cy="3956040"/>
          </a:xfrm>
          <a:prstGeom prst="rect">
            <a:avLst/>
          </a:prstGeom>
          <a:ln w="0">
            <a:noFill/>
          </a:ln>
        </p:spPr>
      </p:pic>
      <p:sp>
        <p:nvSpPr>
          <p:cNvPr id="42" name=""/>
          <p:cNvSpPr/>
          <p:nvPr/>
        </p:nvSpPr>
        <p:spPr>
          <a:xfrm>
            <a:off x="5658480" y="2744640"/>
            <a:ext cx="8575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imes New Roman"/>
              </a:rPr>
              <a:t>Nox4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363240" y="1979640"/>
            <a:ext cx="962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Times New Roman"/>
              </a:rPr>
              <a:t>183 kD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1341360" y="2243160"/>
            <a:ext cx="19368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363240" y="2230560"/>
            <a:ext cx="962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Times New Roman"/>
              </a:rPr>
              <a:t>123 kD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1341360" y="2498760"/>
            <a:ext cx="19368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439560" y="2544840"/>
            <a:ext cx="848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Times New Roman"/>
              </a:rPr>
              <a:t>78 kD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1341360" y="2806560"/>
            <a:ext cx="19368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431640" y="2981160"/>
            <a:ext cx="848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Times New Roman"/>
              </a:rPr>
              <a:t>54 kD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1333440" y="3179880"/>
            <a:ext cx="19224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431640" y="3287880"/>
            <a:ext cx="848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Times New Roman"/>
              </a:rPr>
              <a:t>41 kD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1333440" y="3487680"/>
            <a:ext cx="19224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1932120" y="2038320"/>
            <a:ext cx="14014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3570120" y="2038320"/>
            <a:ext cx="14018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2296440" y="1643040"/>
            <a:ext cx="839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DMSO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3822840" y="1619280"/>
            <a:ext cx="1018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GW1929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 flipH="1">
            <a:off x="5271840" y="2932200"/>
            <a:ext cx="43164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545400" y="860400"/>
            <a:ext cx="5741640" cy="497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3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upplemental Figure 1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3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Original picture of Nox4 detection in wild-type lung homogenates by Western blot 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4-12T18:30:10Z</dcterms:created>
  <dc:creator>bss3jl</dc:creator>
  <dc:description/>
  <dc:language>en-US</dc:language>
  <cp:lastModifiedBy>bss3jl</cp:lastModifiedBy>
  <dcterms:modified xsi:type="dcterms:W3CDTF">2011-04-20T16:24:30Z</dcterms:modified>
  <cp:revision>5</cp:revision>
  <dc:subject/>
  <dc:title>Slide 1</dc:title>
</cp:coreProperties>
</file>